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6858000" cy="93138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7997" autoAdjust="0"/>
  </p:normalViewPr>
  <p:slideViewPr>
    <p:cSldViewPr>
      <p:cViewPr>
        <p:scale>
          <a:sx n="89" d="100"/>
          <a:sy n="89" d="100"/>
        </p:scale>
        <p:origin x="-1824" y="-5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3F1532-BA7A-4C28-A6BF-866E4CCB5F37}" type="datetimeFigureOut">
              <a:rPr lang="en-US" smtClean="0"/>
              <a:t>6/2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01725" y="698500"/>
            <a:ext cx="4654550" cy="34925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24363"/>
            <a:ext cx="5486400" cy="41910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7140"/>
            <a:ext cx="2971800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47140"/>
            <a:ext cx="2971800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5C91A9-B60C-4556-9879-C0A982E8F5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2684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57259-091D-433D-8561-E06C4C9F3D14}" type="datetimeFigureOut">
              <a:rPr lang="en-US" smtClean="0"/>
              <a:t>6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5833-773A-42ED-AF6D-537DCB074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201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57259-091D-433D-8561-E06C4C9F3D14}" type="datetimeFigureOut">
              <a:rPr lang="en-US" smtClean="0"/>
              <a:t>6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5833-773A-42ED-AF6D-537DCB074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728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57259-091D-433D-8561-E06C4C9F3D14}" type="datetimeFigureOut">
              <a:rPr lang="en-US" smtClean="0"/>
              <a:t>6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5833-773A-42ED-AF6D-537DCB074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786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57259-091D-433D-8561-E06C4C9F3D14}" type="datetimeFigureOut">
              <a:rPr lang="en-US" smtClean="0"/>
              <a:t>6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5833-773A-42ED-AF6D-537DCB074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68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57259-091D-433D-8561-E06C4C9F3D14}" type="datetimeFigureOut">
              <a:rPr lang="en-US" smtClean="0"/>
              <a:t>6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5833-773A-42ED-AF6D-537DCB074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422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57259-091D-433D-8561-E06C4C9F3D14}" type="datetimeFigureOut">
              <a:rPr lang="en-US" smtClean="0"/>
              <a:t>6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5833-773A-42ED-AF6D-537DCB074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469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57259-091D-433D-8561-E06C4C9F3D14}" type="datetimeFigureOut">
              <a:rPr lang="en-US" smtClean="0"/>
              <a:t>6/2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5833-773A-42ED-AF6D-537DCB074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63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57259-091D-433D-8561-E06C4C9F3D14}" type="datetimeFigureOut">
              <a:rPr lang="en-US" smtClean="0"/>
              <a:t>6/2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5833-773A-42ED-AF6D-537DCB074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430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57259-091D-433D-8561-E06C4C9F3D14}" type="datetimeFigureOut">
              <a:rPr lang="en-US" smtClean="0"/>
              <a:t>6/2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5833-773A-42ED-AF6D-537DCB074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155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57259-091D-433D-8561-E06C4C9F3D14}" type="datetimeFigureOut">
              <a:rPr lang="en-US" smtClean="0"/>
              <a:t>6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5833-773A-42ED-AF6D-537DCB074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918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57259-091D-433D-8561-E06C4C9F3D14}" type="datetimeFigureOut">
              <a:rPr lang="en-US" smtClean="0"/>
              <a:t>6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5833-773A-42ED-AF6D-537DCB074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919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457259-091D-433D-8561-E06C4C9F3D14}" type="datetimeFigureOut">
              <a:rPr lang="en-US" smtClean="0"/>
              <a:t>6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C5833-773A-42ED-AF6D-537DCB074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049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microsoft.com/office/2007/relationships/hdphoto" Target="../media/hdphoto5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11" Type="http://schemas.openxmlformats.org/officeDocument/2006/relationships/image" Target="../media/image6.jpeg"/><Relationship Id="rId5" Type="http://schemas.microsoft.com/office/2007/relationships/hdphoto" Target="../media/hdphoto2.wdp"/><Relationship Id="rId10" Type="http://schemas.openxmlformats.org/officeDocument/2006/relationships/image" Target="../media/image5.jpe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/>
          <p:cNvSpPr txBox="1"/>
          <p:nvPr/>
        </p:nvSpPr>
        <p:spPr>
          <a:xfrm>
            <a:off x="186795" y="138987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1 Fig.</a:t>
            </a:r>
            <a:endParaRPr lang="en-US" b="1" dirty="0"/>
          </a:p>
        </p:txBody>
      </p:sp>
      <p:grpSp>
        <p:nvGrpSpPr>
          <p:cNvPr id="31" name="Group 30"/>
          <p:cNvGrpSpPr/>
          <p:nvPr/>
        </p:nvGrpSpPr>
        <p:grpSpPr>
          <a:xfrm>
            <a:off x="2353671" y="381000"/>
            <a:ext cx="4732929" cy="4381901"/>
            <a:chOff x="1752600" y="1695094"/>
            <a:chExt cx="4732929" cy="4381901"/>
          </a:xfrm>
        </p:grpSpPr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2810" y="1726702"/>
              <a:ext cx="2651760" cy="397054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2810" y="2141855"/>
              <a:ext cx="2651760" cy="380332"/>
            </a:xfrm>
            <a:prstGeom prst="rect">
              <a:avLst/>
            </a:prstGeom>
          </p:spPr>
        </p:pic>
        <p:sp>
          <p:nvSpPr>
            <p:cNvPr id="46" name="Rectangle 45"/>
            <p:cNvSpPr/>
            <p:nvPr/>
          </p:nvSpPr>
          <p:spPr>
            <a:xfrm>
              <a:off x="2819402" y="1695094"/>
              <a:ext cx="2653966" cy="81358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8" name="Straight Connector 47"/>
            <p:cNvCxnSpPr/>
            <p:nvPr/>
          </p:nvCxnSpPr>
          <p:spPr>
            <a:xfrm flipV="1">
              <a:off x="2819402" y="2139678"/>
              <a:ext cx="2665168" cy="2177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/>
            <p:cNvSpPr txBox="1"/>
            <p:nvPr/>
          </p:nvSpPr>
          <p:spPr>
            <a:xfrm>
              <a:off x="5499810" y="1723842"/>
              <a:ext cx="9857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-bet          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5499810" y="2116510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2819401" y="2638242"/>
              <a:ext cx="2676521" cy="81358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56" name="Picture 55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35" t="37697" r="3998" b="17082"/>
            <a:stretch/>
          </p:blipFill>
          <p:spPr>
            <a:xfrm>
              <a:off x="2830627" y="2671915"/>
              <a:ext cx="2651760" cy="346199"/>
            </a:xfrm>
            <a:prstGeom prst="rect">
              <a:avLst/>
            </a:prstGeom>
          </p:spPr>
        </p:pic>
        <p:cxnSp>
          <p:nvCxnSpPr>
            <p:cNvPr id="59" name="Straight Connector 58"/>
            <p:cNvCxnSpPr/>
            <p:nvPr/>
          </p:nvCxnSpPr>
          <p:spPr>
            <a:xfrm>
              <a:off x="2831441" y="3018114"/>
              <a:ext cx="2622643" cy="1134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2" name="Picture 61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7" t="13006" r="1" b="20783"/>
            <a:stretch/>
          </p:blipFill>
          <p:spPr>
            <a:xfrm>
              <a:off x="2832131" y="3055408"/>
              <a:ext cx="2635567" cy="361580"/>
            </a:xfrm>
            <a:prstGeom prst="rect">
              <a:avLst/>
            </a:prstGeom>
          </p:spPr>
        </p:pic>
        <p:sp>
          <p:nvSpPr>
            <p:cNvPr id="63" name="TextBox 62"/>
            <p:cNvSpPr txBox="1"/>
            <p:nvPr/>
          </p:nvSpPr>
          <p:spPr>
            <a:xfrm>
              <a:off x="5499810" y="2689824"/>
              <a:ext cx="5529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-bet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5499810" y="3091201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2865285" y="4451133"/>
              <a:ext cx="31545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1   10    0     1   10     0    1   10 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Right Brace 65"/>
            <p:cNvSpPr/>
            <p:nvPr/>
          </p:nvSpPr>
          <p:spPr>
            <a:xfrm rot="5400000">
              <a:off x="3205416" y="4359808"/>
              <a:ext cx="95253" cy="77287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" name="Right Brace 66"/>
            <p:cNvSpPr/>
            <p:nvPr/>
          </p:nvSpPr>
          <p:spPr>
            <a:xfrm rot="5400000">
              <a:off x="4127573" y="4393324"/>
              <a:ext cx="95253" cy="70584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8" name="Right Brace 67"/>
            <p:cNvSpPr/>
            <p:nvPr/>
          </p:nvSpPr>
          <p:spPr>
            <a:xfrm rot="5400000">
              <a:off x="5008406" y="4359303"/>
              <a:ext cx="106364" cy="784992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9" name="TextBox 68"/>
            <p:cNvSpPr txBox="1"/>
            <p:nvPr/>
          </p:nvSpPr>
          <p:spPr>
            <a:xfrm rot="16200000">
              <a:off x="3054951" y="4817034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M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 rot="16200000">
              <a:off x="3512497" y="5273890"/>
              <a:ext cx="13292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M </a:t>
              </a:r>
              <a:r>
                <a:rPr lang="en-US" sz="12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12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.tb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MOI1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 rot="16200000">
              <a:off x="4378497" y="5273890"/>
              <a:ext cx="13292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M</a:t>
              </a:r>
              <a:r>
                <a:rPr lang="en-US" sz="12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+ </a:t>
              </a:r>
              <a:r>
                <a:rPr lang="en-US" sz="12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.tb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MOI5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5458224" y="4451133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smtClean="0">
                  <a:latin typeface="Arial" panose="020B0604020202020204" pitchFamily="34" charset="0"/>
                  <a:cs typeface="Arial" panose="020B0604020202020204" pitchFamily="34" charset="0"/>
                </a:rPr>
                <a:t>µg/ml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Rectangle 72"/>
            <p:cNvSpPr/>
            <p:nvPr/>
          </p:nvSpPr>
          <p:spPr>
            <a:xfrm>
              <a:off x="2819400" y="3552642"/>
              <a:ext cx="2653939" cy="81358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4" name="Straight Connector 73"/>
            <p:cNvCxnSpPr/>
            <p:nvPr/>
          </p:nvCxnSpPr>
          <p:spPr>
            <a:xfrm>
              <a:off x="2819402" y="3943860"/>
              <a:ext cx="2646721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/>
            <p:cNvSpPr txBox="1"/>
            <p:nvPr/>
          </p:nvSpPr>
          <p:spPr>
            <a:xfrm>
              <a:off x="5499810" y="3604224"/>
              <a:ext cx="5529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-bet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499810" y="4005601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7" name="Picture 76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000" t="37118" r="1667" b="24235"/>
            <a:stretch/>
          </p:blipFill>
          <p:spPr>
            <a:xfrm>
              <a:off x="2844850" y="3594579"/>
              <a:ext cx="2651073" cy="305902"/>
            </a:xfrm>
            <a:prstGeom prst="rect">
              <a:avLst/>
            </a:prstGeom>
          </p:spPr>
        </p:pic>
        <p:pic>
          <p:nvPicPr>
            <p:cNvPr id="78" name="Picture 77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000" t="28835" r="1667" b="21779"/>
            <a:stretch/>
          </p:blipFill>
          <p:spPr>
            <a:xfrm>
              <a:off x="2837587" y="3985118"/>
              <a:ext cx="2617542" cy="352237"/>
            </a:xfrm>
            <a:prstGeom prst="rect">
              <a:avLst/>
            </a:prstGeom>
          </p:spPr>
        </p:pic>
        <p:sp>
          <p:nvSpPr>
            <p:cNvPr id="79" name="TextBox 78"/>
            <p:cNvSpPr txBox="1"/>
            <p:nvPr/>
          </p:nvSpPr>
          <p:spPr>
            <a:xfrm>
              <a:off x="1752600" y="1981200"/>
              <a:ext cx="8691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bject 1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1752600" y="2923401"/>
              <a:ext cx="8691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bject 2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1752600" y="3837801"/>
              <a:ext cx="8691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bject 3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1074671" y="4835098"/>
            <a:ext cx="7620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T-bet and GAPDH expression in three subject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e-expose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 and 10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µl/ml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MC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3) we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fected with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.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MOI1 and 5 or left uninfected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 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ote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sates we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zed with SDS/PAGE followed by western blotting with T-bet and GAPDH antibodie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-Be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GAPDH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fro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ree independent experiments from three subject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show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4936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29</TotalTime>
  <Words>105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jata Sarkar</dc:creator>
  <cp:lastModifiedBy>Srijata Sarkar</cp:lastModifiedBy>
  <cp:revision>269</cp:revision>
  <cp:lastPrinted>2019-04-06T13:36:01Z</cp:lastPrinted>
  <dcterms:created xsi:type="dcterms:W3CDTF">2017-06-28T15:45:14Z</dcterms:created>
  <dcterms:modified xsi:type="dcterms:W3CDTF">2019-06-20T22:52:20Z</dcterms:modified>
</cp:coreProperties>
</file>